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7D02C28-0936-43EB-B730-31532EB3FD5A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65B12B7-CEB6-4A4D-8DAB-64C278D091BB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E3112-9589-4DDB-B8FE-45A110410B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102B2-0C05-440D-9651-AC509770B8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D802D1-2BA6-440E-9176-693C12581F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F911D-33F7-497C-BFBE-7287EF2D4E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33521-0C21-4244-A6BD-AB79C31562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669E4-A055-444F-AE78-E6149E3CE2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0CE4B-66EC-4BD4-84B2-B33E470F54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5144D-96A8-4077-98C5-91E686EF5A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13815F-9A7C-435E-949E-52F931B7FA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BF1714-66AC-4233-85AB-66A4119C57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C0E1E-1302-43CA-8C56-25F1967A3B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09C93-1BA7-420D-9CEC-5D68E85ADA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EC86DED-555E-49EF-A326-4EAD1E29D431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ZoneTexte 4"/>
          <p:cNvSpPr/>
          <p:nvPr/>
        </p:nvSpPr>
        <p:spPr>
          <a:xfrm>
            <a:off x="282240" y="369720"/>
            <a:ext cx="267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% of total MRM transition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ZoneTexte 5"/>
          <p:cNvSpPr/>
          <p:nvPr/>
        </p:nvSpPr>
        <p:spPr>
          <a:xfrm>
            <a:off x="5040" y="0"/>
            <a:ext cx="62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A-P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Graphique 5" descr=""/>
          <p:cNvPicPr/>
          <p:nvPr/>
        </p:nvPicPr>
        <p:blipFill>
          <a:blip r:embed="rId1"/>
          <a:stretch/>
        </p:blipFill>
        <p:spPr>
          <a:xfrm>
            <a:off x="0" y="523800"/>
            <a:ext cx="9144000" cy="6334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ZoneTexte 3"/>
          <p:cNvSpPr/>
          <p:nvPr/>
        </p:nvSpPr>
        <p:spPr>
          <a:xfrm>
            <a:off x="282240" y="484200"/>
            <a:ext cx="267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% of total MRM transition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ZoneTexte 4"/>
          <p:cNvSpPr/>
          <p:nvPr/>
        </p:nvSpPr>
        <p:spPr>
          <a:xfrm>
            <a:off x="14400" y="0"/>
            <a:ext cx="604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B-P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Graphique 4" descr=""/>
          <p:cNvPicPr/>
          <p:nvPr/>
        </p:nvPicPr>
        <p:blipFill>
          <a:blip r:embed="rId1"/>
          <a:stretch/>
        </p:blipFill>
        <p:spPr>
          <a:xfrm>
            <a:off x="152280" y="523800"/>
            <a:ext cx="8991720" cy="6334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ZoneTexte 3"/>
          <p:cNvSpPr/>
          <p:nvPr/>
        </p:nvSpPr>
        <p:spPr>
          <a:xfrm>
            <a:off x="282240" y="484200"/>
            <a:ext cx="267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% of total MRM transition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ZoneTexte 4"/>
          <p:cNvSpPr/>
          <p:nvPr/>
        </p:nvSpPr>
        <p:spPr>
          <a:xfrm>
            <a:off x="5400" y="0"/>
            <a:ext cx="54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C-P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Graphique 4" descr=""/>
          <p:cNvPicPr/>
          <p:nvPr/>
        </p:nvPicPr>
        <p:blipFill>
          <a:blip r:embed="rId1"/>
          <a:stretch/>
        </p:blipFill>
        <p:spPr>
          <a:xfrm>
            <a:off x="0" y="523800"/>
            <a:ext cx="9144000" cy="6334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ZoneTexte 4"/>
          <p:cNvSpPr/>
          <p:nvPr/>
        </p:nvSpPr>
        <p:spPr>
          <a:xfrm>
            <a:off x="282240" y="484200"/>
            <a:ext cx="267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% of total MRM transition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ZoneTexte 5"/>
          <p:cNvSpPr/>
          <p:nvPr/>
        </p:nvSpPr>
        <p:spPr>
          <a:xfrm>
            <a:off x="4320" y="0"/>
            <a:ext cx="65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D-P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" name="Graphique 4" descr=""/>
          <p:cNvPicPr/>
          <p:nvPr/>
        </p:nvPicPr>
        <p:blipFill>
          <a:blip r:embed="rId1"/>
          <a:stretch/>
        </p:blipFill>
        <p:spPr>
          <a:xfrm>
            <a:off x="0" y="523800"/>
            <a:ext cx="9144000" cy="6334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Graphique 2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61" name="ZoneTexte 5"/>
          <p:cNvSpPr/>
          <p:nvPr/>
        </p:nvSpPr>
        <p:spPr>
          <a:xfrm>
            <a:off x="3960" y="0"/>
            <a:ext cx="635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-D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Graphique 1" descr=""/>
          <p:cNvPicPr/>
          <p:nvPr/>
        </p:nvPicPr>
        <p:blipFill>
          <a:blip r:embed="rId1"/>
          <a:stretch/>
        </p:blipFill>
        <p:spPr>
          <a:xfrm>
            <a:off x="1139760" y="0"/>
            <a:ext cx="6407280" cy="6858000"/>
          </a:xfrm>
          <a:prstGeom prst="rect">
            <a:avLst/>
          </a:prstGeom>
          <a:ln w="0">
            <a:noFill/>
          </a:ln>
        </p:spPr>
      </p:pic>
      <p:sp>
        <p:nvSpPr>
          <p:cNvPr id="63" name="ZoneTexte 5"/>
          <p:cNvSpPr/>
          <p:nvPr/>
        </p:nvSpPr>
        <p:spPr>
          <a:xfrm>
            <a:off x="2880" y="0"/>
            <a:ext cx="35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-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4" name=""/>
          <p:cNvGraphicFramePr/>
          <p:nvPr/>
        </p:nvGraphicFramePr>
        <p:xfrm>
          <a:off x="792000" y="239760"/>
          <a:ext cx="1997280" cy="6581880"/>
        </p:xfrm>
        <a:graphic>
          <a:graphicData uri="http://schemas.openxmlformats.org/drawingml/2006/table">
            <a:tbl>
              <a:tblPr/>
              <a:tblGrid>
                <a:gridCol w="998640"/>
                <a:gridCol w="998640"/>
              </a:tblGrid>
              <a:tr h="3128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tegori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equenci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DR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5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Go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R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ch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ho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m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mi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nu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pl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C t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 DR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 Go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 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 ch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 ho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 m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 mi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 nu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 pl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 t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 Go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 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 ch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 ho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 m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 mi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 nu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 pl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 t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 DR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 Go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 R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 ch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 ho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 m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 mi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 nu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 pl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 t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</a:tr>
            </a:tbl>
          </a:graphicData>
        </a:graphic>
      </p:graphicFrame>
      <p:sp>
        <p:nvSpPr>
          <p:cNvPr id="65" name="ZoneTexte 2"/>
          <p:cNvSpPr/>
          <p:nvPr/>
        </p:nvSpPr>
        <p:spPr>
          <a:xfrm>
            <a:off x="1330560" y="-101520"/>
            <a:ext cx="87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ble 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6" name=""/>
          <p:cNvGraphicFramePr/>
          <p:nvPr/>
        </p:nvGraphicFramePr>
        <p:xfrm>
          <a:off x="3209760" y="241200"/>
          <a:ext cx="4853160" cy="5956560"/>
        </p:xfrm>
        <a:graphic>
          <a:graphicData uri="http://schemas.openxmlformats.org/drawingml/2006/table">
            <a:tbl>
              <a:tblPr/>
              <a:tblGrid>
                <a:gridCol w="914400"/>
                <a:gridCol w="1344600"/>
                <a:gridCol w="1346400"/>
                <a:gridCol w="1247760"/>
              </a:tblGrid>
              <a:tr h="371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ariabl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bservation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a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d. devi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2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:0/18: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85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3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:0/18: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.09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.37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3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:0/18: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.77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7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1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:1/18: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6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0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3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:1/18: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62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15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:1/18: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5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3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2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:0/18: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6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:0/18: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54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47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2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:0/18: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36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3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:1/18: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8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2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:1/18: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6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9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:2/18: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07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28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29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:2/18: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3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43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:3/18: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67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64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3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:3/18: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19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55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7" name="ZoneTexte 4"/>
          <p:cNvSpPr/>
          <p:nvPr/>
        </p:nvSpPr>
        <p:spPr>
          <a:xfrm>
            <a:off x="4836960" y="-10152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ble 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ZoneTexte 5"/>
          <p:cNvSpPr/>
          <p:nvPr/>
        </p:nvSpPr>
        <p:spPr>
          <a:xfrm>
            <a:off x="2880" y="0"/>
            <a:ext cx="39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-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4T12:48:04Z</dcterms:created>
  <dc:creator>eric</dc:creator>
  <dc:description/>
  <dc:language>en-US</dc:language>
  <cp:lastModifiedBy>eric</cp:lastModifiedBy>
  <cp:lastPrinted>2012-02-24T13:07:01Z</cp:lastPrinted>
  <dcterms:modified xsi:type="dcterms:W3CDTF">2012-06-16T09:18:09Z</dcterms:modified>
  <cp:revision>14</cp:revision>
  <dc:subject/>
  <dc:title>Présentation PowerPoint</dc:title>
</cp:coreProperties>
</file>